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84" y="177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56663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37806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90754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55775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18943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69246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97511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56136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45847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00270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017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9B27E-1932-4BBD-A7D9-2871883A7F89}" type="datetimeFigureOut">
              <a:rPr lang="en-CA" smtClean="0"/>
              <a:t>2019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9D069-1D22-46C1-B323-C098B3E2AE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56578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CA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 Spectrum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Content Placeholder 11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647" t="831" r="2887" b="-1"/>
          <a:stretch/>
        </p:blipFill>
        <p:spPr>
          <a:xfrm>
            <a:off x="379273" y="1437663"/>
            <a:ext cx="8417885" cy="4651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2726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CA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DEPTq135 Spectrum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Content Placeholder 1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443" t="1398" r="2885"/>
          <a:stretch/>
        </p:blipFill>
        <p:spPr>
          <a:xfrm>
            <a:off x="376401" y="1690689"/>
            <a:ext cx="8425304" cy="46190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5513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CA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CA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HSQC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pectrum 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1257" t="2913" r="1"/>
          <a:stretch/>
        </p:blipFill>
        <p:spPr>
          <a:xfrm>
            <a:off x="382847" y="1718439"/>
            <a:ext cx="8359416" cy="44179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82800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CA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CA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gH2BC Spectrum 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1359" t="2534"/>
          <a:stretch/>
        </p:blipFill>
        <p:spPr>
          <a:xfrm>
            <a:off x="310198" y="1277004"/>
            <a:ext cx="8466779" cy="4496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23140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CA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CA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HMBC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pectrum 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1257" t="3480" r="1"/>
          <a:stretch/>
        </p:blipFill>
        <p:spPr>
          <a:xfrm>
            <a:off x="193659" y="1623845"/>
            <a:ext cx="8558637" cy="4496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1754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14</Words>
  <Application>Microsoft Office PowerPoint</Application>
  <PresentationFormat>On-screen Show (4:3)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1H Spectrum</vt:lpstr>
      <vt:lpstr>13C DEPTq135 Spectrum</vt:lpstr>
      <vt:lpstr>1H13C gHSQC Spectrum </vt:lpstr>
      <vt:lpstr>1H13C gH2BC Spectrum </vt:lpstr>
      <vt:lpstr>1H13C gHMBC Spectrum </vt:lpstr>
    </vt:vector>
  </TitlesOfParts>
  <Company>AAFC-AA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H Spectrum</dc:title>
  <dc:creator>Kirby, Chris</dc:creator>
  <cp:lastModifiedBy>McCallum, Jason</cp:lastModifiedBy>
  <cp:revision>4</cp:revision>
  <dcterms:created xsi:type="dcterms:W3CDTF">2019-05-10T13:49:10Z</dcterms:created>
  <dcterms:modified xsi:type="dcterms:W3CDTF">2019-06-13T13:48:22Z</dcterms:modified>
</cp:coreProperties>
</file>